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7"/>
    <p:restoredTop sz="94522"/>
  </p:normalViewPr>
  <p:slideViewPr>
    <p:cSldViewPr snapToGrid="0">
      <p:cViewPr varScale="1">
        <p:scale>
          <a:sx n="91" d="100"/>
          <a:sy n="91" d="100"/>
        </p:scale>
        <p:origin x="17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1034B051-D76B-1093-DE5D-E6D0F1C097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61F439E2-B6EA-DFBC-AF1F-DBAED5B14A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89D1149-86CA-2D64-8E94-66B04FFC9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83B45EF8-DA21-C22E-6397-175D8BAA9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6950AF31-B576-46B0-64B3-32A06A49B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637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DF32B50-FD77-DF11-B8C9-51E7D20E3B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E63AA0EE-E493-C4B5-CA21-CDF6B2E99B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19B8B456-8814-B404-91F0-EC94F0462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BA090262-8501-9CC6-95B6-512E15408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543C21A4-2AE7-A941-29F2-D9B83A31B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6411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DC8A9D4F-E8E1-16FA-A2FD-519800133D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72194D10-499A-DF0E-5DAB-A62B210E53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E43DFE4C-4F92-590C-46AA-CFE5FCC91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3CE3D09-5D85-CDD0-69B6-2EB4131BB4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74265072-56ED-C088-3BC5-E2E6060E9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63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5D043AF-2B4A-09C8-9D9C-4DF5C47E0B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2A122038-670E-44BC-6FFD-C91770D232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E06E308F-53E4-4579-8537-65765AD24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BE83029A-2C9C-AB35-B168-FFC1BEC1B8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3E502B85-5C0F-9567-3E5D-861C7BE59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329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76438DFD-733C-3A04-F7AC-4ABA515CC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3C916626-97FA-3239-11FC-6442E191B0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73EF627E-54DD-634A-E991-ABDFD6011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848F07C-4832-ADFE-DC89-AA69ADAF8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B231510-16E4-3F9F-FB74-404FEB6E6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718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E03C63ED-E217-77E5-90C0-E6A0B3EA96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91C91472-23E0-623F-D60F-42497A7CF3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9279C90D-EDBC-E780-78ED-2B1C683DCB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B682141-EB8C-0CD4-39FB-980F00BE5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C38FD389-3144-47ED-1E41-4744B200B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B94126D4-E245-6323-2EB4-33D409D09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689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60B61EB-FED5-1D9C-3288-3041E145E0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41701327-8C2C-A0FF-ABD3-8A9BF01B57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94109999-88D7-E76F-78A6-69E970F890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4F4C5BAC-FF1C-F2B5-5280-4CAE11618D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C0BF8571-FF6A-CB9B-A3E9-A63E6838C0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25F5E4DE-6D23-FF1E-2EAC-7F502A61E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4565EB51-479B-6CC7-CD9B-71DB770CF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A87AA419-5066-600B-3BB1-A7A0C59F5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246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8EC3EDE-A507-3377-50FB-B96ADF518A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7F5A2F04-B994-947C-C4A7-A4A9FEBD1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184F10A2-4EFA-11AB-DD87-3B867B5A0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3FDCC0F7-6873-7805-C7C7-68238601A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89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0980FB5B-DE4E-4454-C0C3-7625180A31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A8238F98-4A11-A55A-28B1-3996DA03E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C962EF1D-A704-47A2-B1F1-95D1DC903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498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48972E1-CCF4-1691-B567-789645883E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E27651E0-8CA9-91B1-2222-16DDCC590C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5836814C-C0BD-9E11-14B7-C8C72B8979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17751A0-99A8-FA7F-301E-85E029707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14983B79-5B6A-98E4-8214-2B04FBA2E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025D784-49CB-8508-BA25-A0EFC23E6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517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A38E6B69-ACCB-69B9-8224-01F5297D47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AD9CCA10-2787-D0A7-B2A9-343FEAB210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6E1D85DD-20AE-9495-2592-46D6948F8B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9356478-69A0-1947-676A-DB4D326CF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69837480-4D1D-7E5A-8F50-3BD8E4207C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E83902B4-C89F-D475-7FB9-76F0F6A47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992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97267DE0-2757-2E00-4AEC-09860F75C5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BEBF7FE6-E594-D88B-9273-8739A88B61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52A18383-E50C-7BF2-16F2-4960BBF05E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CAE8D-FB8D-6E48-894C-E31AC3DE5120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3F0AD45-3B94-5004-D53C-ECE01A774F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604118B9-288B-0B55-4665-F00E459782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F6522F-AB74-764C-A181-7057F67731E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676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12" Type="http://schemas.openxmlformats.org/officeDocument/2006/relationships/image" Target="../media/image11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ZoneTexte 17"/>
          <p:cNvSpPr txBox="1"/>
          <p:nvPr/>
        </p:nvSpPr>
        <p:spPr>
          <a:xfrm>
            <a:off x="115747" y="115747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. S4</a:t>
            </a:r>
            <a:endParaRPr lang="fr-FR" dirty="0"/>
          </a:p>
        </p:txBody>
      </p:sp>
      <p:grpSp>
        <p:nvGrpSpPr>
          <p:cNvPr id="2" name="Groupe 1"/>
          <p:cNvGrpSpPr/>
          <p:nvPr/>
        </p:nvGrpSpPr>
        <p:grpSpPr>
          <a:xfrm>
            <a:off x="6171383" y="1996948"/>
            <a:ext cx="4938385" cy="3588309"/>
            <a:chOff x="3338845" y="-37113"/>
            <a:chExt cx="4938385" cy="3588309"/>
          </a:xfrm>
        </p:grpSpPr>
        <p:grpSp>
          <p:nvGrpSpPr>
            <p:cNvPr id="19" name="Groupe 18"/>
            <p:cNvGrpSpPr/>
            <p:nvPr/>
          </p:nvGrpSpPr>
          <p:grpSpPr>
            <a:xfrm>
              <a:off x="3751508" y="32622"/>
              <a:ext cx="2267712" cy="2320042"/>
              <a:chOff x="2641007" y="700755"/>
              <a:chExt cx="4836562" cy="4520726"/>
            </a:xfrm>
          </p:grpSpPr>
          <p:grpSp>
            <p:nvGrpSpPr>
              <p:cNvPr id="20" name="Groupe 19"/>
              <p:cNvGrpSpPr/>
              <p:nvPr/>
            </p:nvGrpSpPr>
            <p:grpSpPr>
              <a:xfrm>
                <a:off x="2641007" y="700755"/>
                <a:ext cx="4836562" cy="4520726"/>
                <a:chOff x="2666646" y="-76912"/>
                <a:chExt cx="6858708" cy="6934912"/>
              </a:xfrm>
            </p:grpSpPr>
            <p:pic>
              <p:nvPicPr>
                <p:cNvPr id="25" name="Image 24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666646" y="0"/>
                  <a:ext cx="6858708" cy="6858000"/>
                </a:xfrm>
                <a:prstGeom prst="rect">
                  <a:avLst/>
                </a:prstGeom>
              </p:spPr>
            </p:pic>
            <p:sp>
              <p:nvSpPr>
                <p:cNvPr id="26" name="Forme libre 25"/>
                <p:cNvSpPr/>
                <p:nvPr/>
              </p:nvSpPr>
              <p:spPr>
                <a:xfrm>
                  <a:off x="3136121" y="-76912"/>
                  <a:ext cx="5751504" cy="6811279"/>
                </a:xfrm>
                <a:custGeom>
                  <a:avLst/>
                  <a:gdLst>
                    <a:gd name="connsiteX0" fmla="*/ 154008 w 5751504"/>
                    <a:gd name="connsiteY0" fmla="*/ 76912 h 6811279"/>
                    <a:gd name="connsiteX1" fmla="*/ 102734 w 5751504"/>
                    <a:gd name="connsiteY1" fmla="*/ 598205 h 6811279"/>
                    <a:gd name="connsiteX2" fmla="*/ 145463 w 5751504"/>
                    <a:gd name="connsiteY2" fmla="*/ 709301 h 6811279"/>
                    <a:gd name="connsiteX3" fmla="*/ 154008 w 5751504"/>
                    <a:gd name="connsiteY3" fmla="*/ 888762 h 6811279"/>
                    <a:gd name="connsiteX4" fmla="*/ 60005 w 5751504"/>
                    <a:gd name="connsiteY4" fmla="*/ 1290415 h 6811279"/>
                    <a:gd name="connsiteX5" fmla="*/ 51459 w 5751504"/>
                    <a:gd name="connsiteY5" fmla="*/ 2042445 h 6811279"/>
                    <a:gd name="connsiteX6" fmla="*/ 68550 w 5751504"/>
                    <a:gd name="connsiteY6" fmla="*/ 2427005 h 6811279"/>
                    <a:gd name="connsiteX7" fmla="*/ 111279 w 5751504"/>
                    <a:gd name="connsiteY7" fmla="*/ 2939753 h 6811279"/>
                    <a:gd name="connsiteX8" fmla="*/ 184 w 5751504"/>
                    <a:gd name="connsiteY8" fmla="*/ 3110669 h 6811279"/>
                    <a:gd name="connsiteX9" fmla="*/ 85642 w 5751504"/>
                    <a:gd name="connsiteY9" fmla="*/ 3469592 h 6811279"/>
                    <a:gd name="connsiteX10" fmla="*/ 111279 w 5751504"/>
                    <a:gd name="connsiteY10" fmla="*/ 3956702 h 6811279"/>
                    <a:gd name="connsiteX11" fmla="*/ 154008 w 5751504"/>
                    <a:gd name="connsiteY11" fmla="*/ 4204530 h 6811279"/>
                    <a:gd name="connsiteX12" fmla="*/ 230921 w 5751504"/>
                    <a:gd name="connsiteY12" fmla="*/ 4289988 h 6811279"/>
                    <a:gd name="connsiteX13" fmla="*/ 188192 w 5751504"/>
                    <a:gd name="connsiteY13" fmla="*/ 4452359 h 6811279"/>
                    <a:gd name="connsiteX14" fmla="*/ 145463 w 5751504"/>
                    <a:gd name="connsiteY14" fmla="*/ 4520725 h 6811279"/>
                    <a:gd name="connsiteX15" fmla="*/ 265104 w 5751504"/>
                    <a:gd name="connsiteY15" fmla="*/ 4631820 h 6811279"/>
                    <a:gd name="connsiteX16" fmla="*/ 436020 w 5751504"/>
                    <a:gd name="connsiteY16" fmla="*/ 4922377 h 6811279"/>
                    <a:gd name="connsiteX17" fmla="*/ 683848 w 5751504"/>
                    <a:gd name="connsiteY17" fmla="*/ 4939469 h 6811279"/>
                    <a:gd name="connsiteX18" fmla="*/ 786397 w 5751504"/>
                    <a:gd name="connsiteY18" fmla="*/ 5204388 h 6811279"/>
                    <a:gd name="connsiteX19" fmla="*/ 1042771 w 5751504"/>
                    <a:gd name="connsiteY19" fmla="*/ 5315484 h 6811279"/>
                    <a:gd name="connsiteX20" fmla="*/ 1230778 w 5751504"/>
                    <a:gd name="connsiteY20" fmla="*/ 5230026 h 6811279"/>
                    <a:gd name="connsiteX21" fmla="*/ 1230778 w 5751504"/>
                    <a:gd name="connsiteY21" fmla="*/ 5520583 h 6811279"/>
                    <a:gd name="connsiteX22" fmla="*/ 1623885 w 5751504"/>
                    <a:gd name="connsiteY22" fmla="*/ 5768411 h 6811279"/>
                    <a:gd name="connsiteX23" fmla="*/ 1683706 w 5751504"/>
                    <a:gd name="connsiteY23" fmla="*/ 5930781 h 6811279"/>
                    <a:gd name="connsiteX24" fmla="*/ 1828984 w 5751504"/>
                    <a:gd name="connsiteY24" fmla="*/ 6289704 h 6811279"/>
                    <a:gd name="connsiteX25" fmla="*/ 2119541 w 5751504"/>
                    <a:gd name="connsiteY25" fmla="*/ 6631536 h 6811279"/>
                    <a:gd name="connsiteX26" fmla="*/ 2487010 w 5751504"/>
                    <a:gd name="connsiteY26" fmla="*/ 6793906 h 6811279"/>
                    <a:gd name="connsiteX27" fmla="*/ 2957029 w 5751504"/>
                    <a:gd name="connsiteY27" fmla="*/ 6776815 h 6811279"/>
                    <a:gd name="connsiteX28" fmla="*/ 3315952 w 5751504"/>
                    <a:gd name="connsiteY28" fmla="*/ 6528987 h 6811279"/>
                    <a:gd name="connsiteX29" fmla="*/ 3418502 w 5751504"/>
                    <a:gd name="connsiteY29" fmla="*/ 6323887 h 6811279"/>
                    <a:gd name="connsiteX30" fmla="*/ 3427048 w 5751504"/>
                    <a:gd name="connsiteY30" fmla="*/ 6170063 h 6811279"/>
                    <a:gd name="connsiteX31" fmla="*/ 3512506 w 5751504"/>
                    <a:gd name="connsiteY31" fmla="*/ 5913689 h 6811279"/>
                    <a:gd name="connsiteX32" fmla="*/ 3572326 w 5751504"/>
                    <a:gd name="connsiteY32" fmla="*/ 5734228 h 6811279"/>
                    <a:gd name="connsiteX33" fmla="*/ 3811608 w 5751504"/>
                    <a:gd name="connsiteY33" fmla="*/ 5597495 h 6811279"/>
                    <a:gd name="connsiteX34" fmla="*/ 4161986 w 5751504"/>
                    <a:gd name="connsiteY34" fmla="*/ 5400942 h 6811279"/>
                    <a:gd name="connsiteX35" fmla="*/ 4632005 w 5751504"/>
                    <a:gd name="connsiteY35" fmla="*/ 4734370 h 6811279"/>
                    <a:gd name="connsiteX36" fmla="*/ 4956745 w 5751504"/>
                    <a:gd name="connsiteY36" fmla="*/ 4110527 h 6811279"/>
                    <a:gd name="connsiteX37" fmla="*/ 5324214 w 5751504"/>
                    <a:gd name="connsiteY37" fmla="*/ 3315768 h 6811279"/>
                    <a:gd name="connsiteX38" fmla="*/ 5469493 w 5751504"/>
                    <a:gd name="connsiteY38" fmla="*/ 2435551 h 6811279"/>
                    <a:gd name="connsiteX39" fmla="*/ 5606225 w 5751504"/>
                    <a:gd name="connsiteY39" fmla="*/ 1888620 h 6811279"/>
                    <a:gd name="connsiteX40" fmla="*/ 5648954 w 5751504"/>
                    <a:gd name="connsiteY40" fmla="*/ 1350235 h 6811279"/>
                    <a:gd name="connsiteX41" fmla="*/ 5657500 w 5751504"/>
                    <a:gd name="connsiteY41" fmla="*/ 700755 h 6811279"/>
                    <a:gd name="connsiteX42" fmla="*/ 5751504 w 5751504"/>
                    <a:gd name="connsiteY42" fmla="*/ 0 h 681127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</a:cxnLst>
                  <a:rect l="l" t="t" r="r" b="b"/>
                  <a:pathLst>
                    <a:path w="5751504" h="6811279">
                      <a:moveTo>
                        <a:pt x="154008" y="76912"/>
                      </a:moveTo>
                      <a:cubicBezTo>
                        <a:pt x="129083" y="284859"/>
                        <a:pt x="104158" y="492807"/>
                        <a:pt x="102734" y="598205"/>
                      </a:cubicBezTo>
                      <a:cubicBezTo>
                        <a:pt x="101310" y="703603"/>
                        <a:pt x="136917" y="660875"/>
                        <a:pt x="145463" y="709301"/>
                      </a:cubicBezTo>
                      <a:cubicBezTo>
                        <a:pt x="154009" y="757727"/>
                        <a:pt x="168251" y="791910"/>
                        <a:pt x="154008" y="888762"/>
                      </a:cubicBezTo>
                      <a:cubicBezTo>
                        <a:pt x="139765" y="985614"/>
                        <a:pt x="77096" y="1098135"/>
                        <a:pt x="60005" y="1290415"/>
                      </a:cubicBezTo>
                      <a:cubicBezTo>
                        <a:pt x="42913" y="1482696"/>
                        <a:pt x="50035" y="1853013"/>
                        <a:pt x="51459" y="2042445"/>
                      </a:cubicBezTo>
                      <a:cubicBezTo>
                        <a:pt x="52883" y="2231877"/>
                        <a:pt x="58580" y="2277454"/>
                        <a:pt x="68550" y="2427005"/>
                      </a:cubicBezTo>
                      <a:cubicBezTo>
                        <a:pt x="78520" y="2576556"/>
                        <a:pt x="122673" y="2825809"/>
                        <a:pt x="111279" y="2939753"/>
                      </a:cubicBezTo>
                      <a:cubicBezTo>
                        <a:pt x="99885" y="3053697"/>
                        <a:pt x="4457" y="3022363"/>
                        <a:pt x="184" y="3110669"/>
                      </a:cubicBezTo>
                      <a:cubicBezTo>
                        <a:pt x="-4089" y="3198975"/>
                        <a:pt x="67126" y="3328586"/>
                        <a:pt x="85642" y="3469592"/>
                      </a:cubicBezTo>
                      <a:cubicBezTo>
                        <a:pt x="104158" y="3610598"/>
                        <a:pt x="99885" y="3834212"/>
                        <a:pt x="111279" y="3956702"/>
                      </a:cubicBezTo>
                      <a:cubicBezTo>
                        <a:pt x="122673" y="4079192"/>
                        <a:pt x="134068" y="4148982"/>
                        <a:pt x="154008" y="4204530"/>
                      </a:cubicBezTo>
                      <a:cubicBezTo>
                        <a:pt x="173948" y="4260078"/>
                        <a:pt x="225224" y="4248683"/>
                        <a:pt x="230921" y="4289988"/>
                      </a:cubicBezTo>
                      <a:cubicBezTo>
                        <a:pt x="236618" y="4331293"/>
                        <a:pt x="202435" y="4413903"/>
                        <a:pt x="188192" y="4452359"/>
                      </a:cubicBezTo>
                      <a:cubicBezTo>
                        <a:pt x="173949" y="4490815"/>
                        <a:pt x="132644" y="4490815"/>
                        <a:pt x="145463" y="4520725"/>
                      </a:cubicBezTo>
                      <a:cubicBezTo>
                        <a:pt x="158282" y="4550635"/>
                        <a:pt x="216678" y="4564878"/>
                        <a:pt x="265104" y="4631820"/>
                      </a:cubicBezTo>
                      <a:cubicBezTo>
                        <a:pt x="313530" y="4698762"/>
                        <a:pt x="366229" y="4871102"/>
                        <a:pt x="436020" y="4922377"/>
                      </a:cubicBezTo>
                      <a:cubicBezTo>
                        <a:pt x="505811" y="4973652"/>
                        <a:pt x="625452" y="4892467"/>
                        <a:pt x="683848" y="4939469"/>
                      </a:cubicBezTo>
                      <a:cubicBezTo>
                        <a:pt x="742244" y="4986471"/>
                        <a:pt x="726577" y="5141719"/>
                        <a:pt x="786397" y="5204388"/>
                      </a:cubicBezTo>
                      <a:cubicBezTo>
                        <a:pt x="846217" y="5267057"/>
                        <a:pt x="968708" y="5311211"/>
                        <a:pt x="1042771" y="5315484"/>
                      </a:cubicBezTo>
                      <a:cubicBezTo>
                        <a:pt x="1116835" y="5319757"/>
                        <a:pt x="1199444" y="5195843"/>
                        <a:pt x="1230778" y="5230026"/>
                      </a:cubicBezTo>
                      <a:cubicBezTo>
                        <a:pt x="1262112" y="5264209"/>
                        <a:pt x="1165260" y="5430852"/>
                        <a:pt x="1230778" y="5520583"/>
                      </a:cubicBezTo>
                      <a:cubicBezTo>
                        <a:pt x="1296296" y="5610314"/>
                        <a:pt x="1548397" y="5700045"/>
                        <a:pt x="1623885" y="5768411"/>
                      </a:cubicBezTo>
                      <a:cubicBezTo>
                        <a:pt x="1699373" y="5836777"/>
                        <a:pt x="1649523" y="5843899"/>
                        <a:pt x="1683706" y="5930781"/>
                      </a:cubicBezTo>
                      <a:cubicBezTo>
                        <a:pt x="1717889" y="6017663"/>
                        <a:pt x="1756345" y="6172912"/>
                        <a:pt x="1828984" y="6289704"/>
                      </a:cubicBezTo>
                      <a:cubicBezTo>
                        <a:pt x="1901623" y="6406496"/>
                        <a:pt x="2009870" y="6547502"/>
                        <a:pt x="2119541" y="6631536"/>
                      </a:cubicBezTo>
                      <a:cubicBezTo>
                        <a:pt x="2229212" y="6715570"/>
                        <a:pt x="2347429" y="6769693"/>
                        <a:pt x="2487010" y="6793906"/>
                      </a:cubicBezTo>
                      <a:cubicBezTo>
                        <a:pt x="2626591" y="6818119"/>
                        <a:pt x="2818872" y="6820968"/>
                        <a:pt x="2957029" y="6776815"/>
                      </a:cubicBezTo>
                      <a:cubicBezTo>
                        <a:pt x="3095186" y="6732662"/>
                        <a:pt x="3239040" y="6604475"/>
                        <a:pt x="3315952" y="6528987"/>
                      </a:cubicBezTo>
                      <a:cubicBezTo>
                        <a:pt x="3392864" y="6453499"/>
                        <a:pt x="3399986" y="6383708"/>
                        <a:pt x="3418502" y="6323887"/>
                      </a:cubicBezTo>
                      <a:cubicBezTo>
                        <a:pt x="3437018" y="6264066"/>
                        <a:pt x="3411381" y="6238429"/>
                        <a:pt x="3427048" y="6170063"/>
                      </a:cubicBezTo>
                      <a:cubicBezTo>
                        <a:pt x="3442715" y="6101697"/>
                        <a:pt x="3512506" y="5913689"/>
                        <a:pt x="3512506" y="5913689"/>
                      </a:cubicBezTo>
                      <a:cubicBezTo>
                        <a:pt x="3536719" y="5841050"/>
                        <a:pt x="3522476" y="5786927"/>
                        <a:pt x="3572326" y="5734228"/>
                      </a:cubicBezTo>
                      <a:cubicBezTo>
                        <a:pt x="3622176" y="5681529"/>
                        <a:pt x="3811608" y="5597495"/>
                        <a:pt x="3811608" y="5597495"/>
                      </a:cubicBezTo>
                      <a:cubicBezTo>
                        <a:pt x="3909885" y="5541947"/>
                        <a:pt x="4025253" y="5544796"/>
                        <a:pt x="4161986" y="5400942"/>
                      </a:cubicBezTo>
                      <a:cubicBezTo>
                        <a:pt x="4298719" y="5257088"/>
                        <a:pt x="4499545" y="4949439"/>
                        <a:pt x="4632005" y="4734370"/>
                      </a:cubicBezTo>
                      <a:cubicBezTo>
                        <a:pt x="4764465" y="4519301"/>
                        <a:pt x="4841377" y="4346961"/>
                        <a:pt x="4956745" y="4110527"/>
                      </a:cubicBezTo>
                      <a:cubicBezTo>
                        <a:pt x="5072113" y="3874093"/>
                        <a:pt x="5238756" y="3594931"/>
                        <a:pt x="5324214" y="3315768"/>
                      </a:cubicBezTo>
                      <a:cubicBezTo>
                        <a:pt x="5409672" y="3036605"/>
                        <a:pt x="5422491" y="2673409"/>
                        <a:pt x="5469493" y="2435551"/>
                      </a:cubicBezTo>
                      <a:cubicBezTo>
                        <a:pt x="5516495" y="2197693"/>
                        <a:pt x="5576315" y="2069506"/>
                        <a:pt x="5606225" y="1888620"/>
                      </a:cubicBezTo>
                      <a:cubicBezTo>
                        <a:pt x="5636135" y="1707734"/>
                        <a:pt x="5640408" y="1548212"/>
                        <a:pt x="5648954" y="1350235"/>
                      </a:cubicBezTo>
                      <a:cubicBezTo>
                        <a:pt x="5657500" y="1152258"/>
                        <a:pt x="5640408" y="925794"/>
                        <a:pt x="5657500" y="700755"/>
                      </a:cubicBezTo>
                      <a:cubicBezTo>
                        <a:pt x="5674592" y="475716"/>
                        <a:pt x="5713048" y="237858"/>
                        <a:pt x="5751504" y="0"/>
                      </a:cubicBezTo>
                    </a:path>
                  </a:pathLst>
                </a:custGeom>
                <a:noFill/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pic>
            <p:nvPicPr>
              <p:cNvPr id="21" name="Image 20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865598" y="2726726"/>
                <a:ext cx="530724" cy="642455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cxnSp>
            <p:nvCxnSpPr>
              <p:cNvPr id="22" name="Connecteur droit 21"/>
              <p:cNvCxnSpPr/>
              <p:nvPr/>
            </p:nvCxnSpPr>
            <p:spPr>
              <a:xfrm flipH="1">
                <a:off x="6255521" y="2718180"/>
                <a:ext cx="610078" cy="537768"/>
              </a:xfrm>
              <a:prstGeom prst="line">
                <a:avLst/>
              </a:prstGeom>
              <a:ln>
                <a:solidFill>
                  <a:schemeClr val="bg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Connecteur droit 22"/>
              <p:cNvCxnSpPr/>
              <p:nvPr/>
            </p:nvCxnSpPr>
            <p:spPr>
              <a:xfrm flipH="1" flipV="1">
                <a:off x="6255521" y="3306085"/>
                <a:ext cx="610076" cy="51275"/>
              </a:xfrm>
              <a:prstGeom prst="line">
                <a:avLst/>
              </a:prstGeom>
              <a:ln>
                <a:solidFill>
                  <a:schemeClr val="bg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ZoneTexte 23">
                <a:extLst>
                  <a:ext uri="{FF2B5EF4-FFF2-40B4-BE49-F238E27FC236}">
                    <a16:creationId xmlns:a16="http://schemas.microsoft.com/office/drawing/2014/main" xmlns="" id="{E936CB28-128B-6CE5-3AC9-C0A99D797AD8}"/>
                  </a:ext>
                </a:extLst>
              </p:cNvPr>
              <p:cNvSpPr txBox="1"/>
              <p:nvPr/>
            </p:nvSpPr>
            <p:spPr>
              <a:xfrm>
                <a:off x="6721969" y="2581347"/>
                <a:ext cx="557960" cy="5397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/>
                    </a:solidFill>
                  </a:rPr>
                  <a:t>*</a:t>
                </a:r>
                <a:endParaRPr lang="en-US" sz="1600" b="1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35" name="ZoneTexte 34"/>
            <p:cNvSpPr txBox="1"/>
            <p:nvPr/>
          </p:nvSpPr>
          <p:spPr>
            <a:xfrm>
              <a:off x="3706676" y="2055446"/>
              <a:ext cx="7617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>
                  <a:solidFill>
                    <a:srgbClr val="FF0000"/>
                  </a:solidFill>
                </a:rPr>
                <a:t>Macrophages</a:t>
              </a:r>
              <a:endParaRPr lang="fr-FR" b="1" dirty="0">
                <a:solidFill>
                  <a:srgbClr val="FF0000"/>
                </a:solidFill>
              </a:endParaRPr>
            </a:p>
          </p:txBody>
        </p:sp>
        <p:sp>
          <p:nvSpPr>
            <p:cNvPr id="36" name="ZoneTexte 35"/>
            <p:cNvSpPr txBox="1"/>
            <p:nvPr/>
          </p:nvSpPr>
          <p:spPr>
            <a:xfrm>
              <a:off x="3714090" y="2172001"/>
              <a:ext cx="42191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>
                  <a:solidFill>
                    <a:srgbClr val="00FA00"/>
                  </a:solidFill>
                </a:rPr>
                <a:t>PAO1</a:t>
              </a:r>
              <a:endParaRPr lang="fr-FR" b="1" dirty="0">
                <a:solidFill>
                  <a:srgbClr val="00FA00"/>
                </a:solidFill>
              </a:endParaRPr>
            </a:p>
          </p:txBody>
        </p:sp>
        <p:grpSp>
          <p:nvGrpSpPr>
            <p:cNvPr id="37" name="Groupe 36"/>
            <p:cNvGrpSpPr/>
            <p:nvPr/>
          </p:nvGrpSpPr>
          <p:grpSpPr>
            <a:xfrm>
              <a:off x="4195548" y="2391465"/>
              <a:ext cx="1048057" cy="1159731"/>
              <a:chOff x="5399392" y="1190248"/>
              <a:chExt cx="1607343" cy="1803464"/>
            </a:xfrm>
          </p:grpSpPr>
          <p:pic>
            <p:nvPicPr>
              <p:cNvPr id="38" name="Image 37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 flipV="1">
                <a:off x="5399392" y="1217700"/>
                <a:ext cx="864248" cy="859991"/>
              </a:xfrm>
              <a:prstGeom prst="rect">
                <a:avLst/>
              </a:prstGeom>
            </p:spPr>
          </p:pic>
          <p:pic>
            <p:nvPicPr>
              <p:cNvPr id="39" name="Image 38"/>
              <p:cNvPicPr>
                <a:picLocks noChangeAspect="1"/>
              </p:cNvPicPr>
              <p:nvPr/>
            </p:nvPicPr>
            <p:blipFill rotWithShape="1">
              <a:blip r:embed="rId5"/>
              <a:srcRect r="18397"/>
              <a:stretch/>
            </p:blipFill>
            <p:spPr>
              <a:xfrm flipV="1">
                <a:off x="6291329" y="1208555"/>
                <a:ext cx="715406" cy="859991"/>
              </a:xfrm>
              <a:prstGeom prst="rect">
                <a:avLst/>
              </a:prstGeom>
            </p:spPr>
          </p:pic>
          <p:pic>
            <p:nvPicPr>
              <p:cNvPr id="40" name="Image 39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flipV="1">
                <a:off x="5399392" y="2104045"/>
                <a:ext cx="881534" cy="889667"/>
              </a:xfrm>
              <a:prstGeom prst="rect">
                <a:avLst/>
              </a:prstGeom>
            </p:spPr>
          </p:pic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xmlns="" id="{E936CB28-128B-6CE5-3AC9-C0A99D797AD8}"/>
                  </a:ext>
                </a:extLst>
              </p:cNvPr>
              <p:cNvSpPr txBox="1"/>
              <p:nvPr/>
            </p:nvSpPr>
            <p:spPr>
              <a:xfrm flipV="1">
                <a:off x="5485001" y="1190248"/>
                <a:ext cx="20014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</p:grpSp>
        <p:grpSp>
          <p:nvGrpSpPr>
            <p:cNvPr id="42" name="Groupe 41">
              <a:extLst>
                <a:ext uri="{FF2B5EF4-FFF2-40B4-BE49-F238E27FC236}">
                  <a16:creationId xmlns:a16="http://schemas.microsoft.com/office/drawing/2014/main" xmlns="" id="{79DD2BBC-91D4-DA70-4BC6-EACD6E1EBDAF}"/>
                </a:ext>
              </a:extLst>
            </p:cNvPr>
            <p:cNvGrpSpPr/>
            <p:nvPr/>
          </p:nvGrpSpPr>
          <p:grpSpPr>
            <a:xfrm>
              <a:off x="6036950" y="32622"/>
              <a:ext cx="2240280" cy="2320042"/>
              <a:chOff x="3815840" y="120535"/>
              <a:chExt cx="2240280" cy="2320042"/>
            </a:xfrm>
          </p:grpSpPr>
          <p:sp>
            <p:nvSpPr>
              <p:cNvPr id="43" name="ZoneTexte 42">
                <a:extLst>
                  <a:ext uri="{FF2B5EF4-FFF2-40B4-BE49-F238E27FC236}">
                    <a16:creationId xmlns:a16="http://schemas.microsoft.com/office/drawing/2014/main" xmlns="" id="{E936CB28-128B-6CE5-3AC9-C0A99D797AD8}"/>
                  </a:ext>
                </a:extLst>
              </p:cNvPr>
              <p:cNvSpPr txBox="1"/>
              <p:nvPr/>
            </p:nvSpPr>
            <p:spPr>
              <a:xfrm>
                <a:off x="3979072" y="2196527"/>
                <a:ext cx="143545" cy="1678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pic>
            <p:nvPicPr>
              <p:cNvPr id="44" name="Image 43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43" b="387"/>
              <a:stretch/>
            </p:blipFill>
            <p:spPr>
              <a:xfrm>
                <a:off x="3815840" y="146266"/>
                <a:ext cx="2240280" cy="2294311"/>
              </a:xfrm>
              <a:prstGeom prst="rect">
                <a:avLst/>
              </a:prstGeom>
            </p:spPr>
          </p:pic>
          <p:sp>
            <p:nvSpPr>
              <p:cNvPr id="45" name="Forme libre 44"/>
              <p:cNvSpPr/>
              <p:nvPr/>
            </p:nvSpPr>
            <p:spPr>
              <a:xfrm>
                <a:off x="3875796" y="120535"/>
                <a:ext cx="2164704" cy="2277736"/>
              </a:xfrm>
              <a:custGeom>
                <a:avLst/>
                <a:gdLst>
                  <a:gd name="connsiteX0" fmla="*/ 0 w 6627328"/>
                  <a:gd name="connsiteY0" fmla="*/ 19456 h 6745121"/>
                  <a:gd name="connsiteX1" fmla="*/ 97277 w 6627328"/>
                  <a:gd name="connsiteY1" fmla="*/ 749030 h 6745121"/>
                  <a:gd name="connsiteX2" fmla="*/ 107005 w 6627328"/>
                  <a:gd name="connsiteY2" fmla="*/ 1118681 h 6745121"/>
                  <a:gd name="connsiteX3" fmla="*/ 214009 w 6627328"/>
                  <a:gd name="connsiteY3" fmla="*/ 1848256 h 6745121"/>
                  <a:gd name="connsiteX4" fmla="*/ 476656 w 6627328"/>
                  <a:gd name="connsiteY4" fmla="*/ 2597285 h 6745121"/>
                  <a:gd name="connsiteX5" fmla="*/ 661481 w 6627328"/>
                  <a:gd name="connsiteY5" fmla="*/ 3326860 h 6745121"/>
                  <a:gd name="connsiteX6" fmla="*/ 924128 w 6627328"/>
                  <a:gd name="connsiteY6" fmla="*/ 3871609 h 6745121"/>
                  <a:gd name="connsiteX7" fmla="*/ 1186775 w 6627328"/>
                  <a:gd name="connsiteY7" fmla="*/ 4241260 h 6745121"/>
                  <a:gd name="connsiteX8" fmla="*/ 1381328 w 6627328"/>
                  <a:gd name="connsiteY8" fmla="*/ 4717915 h 6745121"/>
                  <a:gd name="connsiteX9" fmla="*/ 1877439 w 6627328"/>
                  <a:gd name="connsiteY9" fmla="*/ 5194571 h 6745121"/>
                  <a:gd name="connsiteX10" fmla="*/ 2383277 w 6627328"/>
                  <a:gd name="connsiteY10" fmla="*/ 5573949 h 6745121"/>
                  <a:gd name="connsiteX11" fmla="*/ 2587558 w 6627328"/>
                  <a:gd name="connsiteY11" fmla="*/ 5768502 h 6745121"/>
                  <a:gd name="connsiteX12" fmla="*/ 2694562 w 6627328"/>
                  <a:gd name="connsiteY12" fmla="*/ 5894962 h 6745121"/>
                  <a:gd name="connsiteX13" fmla="*/ 2577830 w 6627328"/>
                  <a:gd name="connsiteY13" fmla="*/ 6264613 h 6745121"/>
                  <a:gd name="connsiteX14" fmla="*/ 2723745 w 6627328"/>
                  <a:gd name="connsiteY14" fmla="*/ 6585626 h 6745121"/>
                  <a:gd name="connsiteX15" fmla="*/ 3064213 w 6627328"/>
                  <a:gd name="connsiteY15" fmla="*/ 6721813 h 6745121"/>
                  <a:gd name="connsiteX16" fmla="*/ 3356043 w 6627328"/>
                  <a:gd name="connsiteY16" fmla="*/ 6712085 h 6745121"/>
                  <a:gd name="connsiteX17" fmla="*/ 3647873 w 6627328"/>
                  <a:gd name="connsiteY17" fmla="*/ 6400800 h 6745121"/>
                  <a:gd name="connsiteX18" fmla="*/ 3725694 w 6627328"/>
                  <a:gd name="connsiteY18" fmla="*/ 6157609 h 6745121"/>
                  <a:gd name="connsiteX19" fmla="*/ 3715966 w 6627328"/>
                  <a:gd name="connsiteY19" fmla="*/ 5904690 h 6745121"/>
                  <a:gd name="connsiteX20" fmla="*/ 3696511 w 6627328"/>
                  <a:gd name="connsiteY20" fmla="*/ 5719864 h 6745121"/>
                  <a:gd name="connsiteX21" fmla="*/ 3550596 w 6627328"/>
                  <a:gd name="connsiteY21" fmla="*/ 5690681 h 6745121"/>
                  <a:gd name="connsiteX22" fmla="*/ 3813243 w 6627328"/>
                  <a:gd name="connsiteY22" fmla="*/ 5603132 h 6745121"/>
                  <a:gd name="connsiteX23" fmla="*/ 4114800 w 6627328"/>
                  <a:gd name="connsiteY23" fmla="*/ 5350213 h 6745121"/>
                  <a:gd name="connsiteX24" fmla="*/ 4134256 w 6627328"/>
                  <a:gd name="connsiteY24" fmla="*/ 5262664 h 6745121"/>
                  <a:gd name="connsiteX25" fmla="*/ 4114800 w 6627328"/>
                  <a:gd name="connsiteY25" fmla="*/ 5175115 h 6745121"/>
                  <a:gd name="connsiteX26" fmla="*/ 4309353 w 6627328"/>
                  <a:gd name="connsiteY26" fmla="*/ 5136205 h 6745121"/>
                  <a:gd name="connsiteX27" fmla="*/ 4717915 w 6627328"/>
                  <a:gd name="connsiteY27" fmla="*/ 5009745 h 6745121"/>
                  <a:gd name="connsiteX28" fmla="*/ 5029200 w 6627328"/>
                  <a:gd name="connsiteY28" fmla="*/ 4776281 h 6745121"/>
                  <a:gd name="connsiteX29" fmla="*/ 5350213 w 6627328"/>
                  <a:gd name="connsiteY29" fmla="*/ 4319081 h 6745121"/>
                  <a:gd name="connsiteX30" fmla="*/ 5622587 w 6627328"/>
                  <a:gd name="connsiteY30" fmla="*/ 3920247 h 6745121"/>
                  <a:gd name="connsiteX31" fmla="*/ 5817141 w 6627328"/>
                  <a:gd name="connsiteY31" fmla="*/ 3472775 h 6745121"/>
                  <a:gd name="connsiteX32" fmla="*/ 5953328 w 6627328"/>
                  <a:gd name="connsiteY32" fmla="*/ 3054485 h 6745121"/>
                  <a:gd name="connsiteX33" fmla="*/ 6138153 w 6627328"/>
                  <a:gd name="connsiteY33" fmla="*/ 2772383 h 6745121"/>
                  <a:gd name="connsiteX34" fmla="*/ 6245158 w 6627328"/>
                  <a:gd name="connsiteY34" fmla="*/ 2490281 h 6745121"/>
                  <a:gd name="connsiteX35" fmla="*/ 6293796 w 6627328"/>
                  <a:gd name="connsiteY35" fmla="*/ 2198451 h 6745121"/>
                  <a:gd name="connsiteX36" fmla="*/ 6468894 w 6627328"/>
                  <a:gd name="connsiteY36" fmla="*/ 1799617 h 6745121"/>
                  <a:gd name="connsiteX37" fmla="*/ 6410528 w 6627328"/>
                  <a:gd name="connsiteY37" fmla="*/ 1595337 h 6745121"/>
                  <a:gd name="connsiteX38" fmla="*/ 6498077 w 6627328"/>
                  <a:gd name="connsiteY38" fmla="*/ 1439694 h 6745121"/>
                  <a:gd name="connsiteX39" fmla="*/ 6527260 w 6627328"/>
                  <a:gd name="connsiteY39" fmla="*/ 1167320 h 6745121"/>
                  <a:gd name="connsiteX40" fmla="*/ 6498077 w 6627328"/>
                  <a:gd name="connsiteY40" fmla="*/ 933856 h 6745121"/>
                  <a:gd name="connsiteX41" fmla="*/ 6624536 w 6627328"/>
                  <a:gd name="connsiteY41" fmla="*/ 671209 h 6745121"/>
                  <a:gd name="connsiteX42" fmla="*/ 6585626 w 6627328"/>
                  <a:gd name="connsiteY42" fmla="*/ 398834 h 6745121"/>
                  <a:gd name="connsiteX43" fmla="*/ 6585626 w 6627328"/>
                  <a:gd name="connsiteY43" fmla="*/ 0 h 674512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</a:cxnLst>
                <a:rect l="l" t="t" r="r" b="b"/>
                <a:pathLst>
                  <a:path w="6627328" h="6745121">
                    <a:moveTo>
                      <a:pt x="0" y="19456"/>
                    </a:moveTo>
                    <a:cubicBezTo>
                      <a:pt x="39721" y="292641"/>
                      <a:pt x="79443" y="565826"/>
                      <a:pt x="97277" y="749030"/>
                    </a:cubicBezTo>
                    <a:cubicBezTo>
                      <a:pt x="115111" y="932234"/>
                      <a:pt x="87550" y="935477"/>
                      <a:pt x="107005" y="1118681"/>
                    </a:cubicBezTo>
                    <a:cubicBezTo>
                      <a:pt x="126460" y="1301885"/>
                      <a:pt x="152400" y="1601822"/>
                      <a:pt x="214009" y="1848256"/>
                    </a:cubicBezTo>
                    <a:cubicBezTo>
                      <a:pt x="275618" y="2094690"/>
                      <a:pt x="402077" y="2350851"/>
                      <a:pt x="476656" y="2597285"/>
                    </a:cubicBezTo>
                    <a:cubicBezTo>
                      <a:pt x="551235" y="2843719"/>
                      <a:pt x="586902" y="3114473"/>
                      <a:pt x="661481" y="3326860"/>
                    </a:cubicBezTo>
                    <a:cubicBezTo>
                      <a:pt x="736060" y="3539247"/>
                      <a:pt x="836579" y="3719209"/>
                      <a:pt x="924128" y="3871609"/>
                    </a:cubicBezTo>
                    <a:cubicBezTo>
                      <a:pt x="1011677" y="4024009"/>
                      <a:pt x="1110575" y="4100209"/>
                      <a:pt x="1186775" y="4241260"/>
                    </a:cubicBezTo>
                    <a:cubicBezTo>
                      <a:pt x="1262975" y="4382311"/>
                      <a:pt x="1266217" y="4559030"/>
                      <a:pt x="1381328" y="4717915"/>
                    </a:cubicBezTo>
                    <a:cubicBezTo>
                      <a:pt x="1496439" y="4876800"/>
                      <a:pt x="1710448" y="5051899"/>
                      <a:pt x="1877439" y="5194571"/>
                    </a:cubicBezTo>
                    <a:cubicBezTo>
                      <a:pt x="2044431" y="5337243"/>
                      <a:pt x="2264924" y="5478294"/>
                      <a:pt x="2383277" y="5573949"/>
                    </a:cubicBezTo>
                    <a:cubicBezTo>
                      <a:pt x="2501630" y="5669604"/>
                      <a:pt x="2535677" y="5715000"/>
                      <a:pt x="2587558" y="5768502"/>
                    </a:cubicBezTo>
                    <a:cubicBezTo>
                      <a:pt x="2639439" y="5822004"/>
                      <a:pt x="2696183" y="5812277"/>
                      <a:pt x="2694562" y="5894962"/>
                    </a:cubicBezTo>
                    <a:cubicBezTo>
                      <a:pt x="2692941" y="5977647"/>
                      <a:pt x="2572966" y="6149502"/>
                      <a:pt x="2577830" y="6264613"/>
                    </a:cubicBezTo>
                    <a:cubicBezTo>
                      <a:pt x="2582694" y="6379724"/>
                      <a:pt x="2642681" y="6509426"/>
                      <a:pt x="2723745" y="6585626"/>
                    </a:cubicBezTo>
                    <a:cubicBezTo>
                      <a:pt x="2804809" y="6661826"/>
                      <a:pt x="2958830" y="6700736"/>
                      <a:pt x="3064213" y="6721813"/>
                    </a:cubicBezTo>
                    <a:cubicBezTo>
                      <a:pt x="3169596" y="6742890"/>
                      <a:pt x="3258766" y="6765587"/>
                      <a:pt x="3356043" y="6712085"/>
                    </a:cubicBezTo>
                    <a:cubicBezTo>
                      <a:pt x="3453320" y="6658583"/>
                      <a:pt x="3586265" y="6493213"/>
                      <a:pt x="3647873" y="6400800"/>
                    </a:cubicBezTo>
                    <a:cubicBezTo>
                      <a:pt x="3709481" y="6308387"/>
                      <a:pt x="3714345" y="6240294"/>
                      <a:pt x="3725694" y="6157609"/>
                    </a:cubicBezTo>
                    <a:cubicBezTo>
                      <a:pt x="3737043" y="6074924"/>
                      <a:pt x="3720830" y="5977647"/>
                      <a:pt x="3715966" y="5904690"/>
                    </a:cubicBezTo>
                    <a:cubicBezTo>
                      <a:pt x="3711102" y="5831733"/>
                      <a:pt x="3724073" y="5755532"/>
                      <a:pt x="3696511" y="5719864"/>
                    </a:cubicBezTo>
                    <a:cubicBezTo>
                      <a:pt x="3668949" y="5684196"/>
                      <a:pt x="3531141" y="5710136"/>
                      <a:pt x="3550596" y="5690681"/>
                    </a:cubicBezTo>
                    <a:cubicBezTo>
                      <a:pt x="3570051" y="5671226"/>
                      <a:pt x="3719209" y="5659877"/>
                      <a:pt x="3813243" y="5603132"/>
                    </a:cubicBezTo>
                    <a:cubicBezTo>
                      <a:pt x="3907277" y="5546387"/>
                      <a:pt x="4061298" y="5406958"/>
                      <a:pt x="4114800" y="5350213"/>
                    </a:cubicBezTo>
                    <a:cubicBezTo>
                      <a:pt x="4168302" y="5293468"/>
                      <a:pt x="4134256" y="5291847"/>
                      <a:pt x="4134256" y="5262664"/>
                    </a:cubicBezTo>
                    <a:cubicBezTo>
                      <a:pt x="4134256" y="5233481"/>
                      <a:pt x="4085617" y="5196192"/>
                      <a:pt x="4114800" y="5175115"/>
                    </a:cubicBezTo>
                    <a:cubicBezTo>
                      <a:pt x="4143983" y="5154039"/>
                      <a:pt x="4208834" y="5163767"/>
                      <a:pt x="4309353" y="5136205"/>
                    </a:cubicBezTo>
                    <a:cubicBezTo>
                      <a:pt x="4409872" y="5108643"/>
                      <a:pt x="4597941" y="5069732"/>
                      <a:pt x="4717915" y="5009745"/>
                    </a:cubicBezTo>
                    <a:cubicBezTo>
                      <a:pt x="4837889" y="4949758"/>
                      <a:pt x="4923817" y="4891392"/>
                      <a:pt x="5029200" y="4776281"/>
                    </a:cubicBezTo>
                    <a:cubicBezTo>
                      <a:pt x="5134583" y="4661170"/>
                      <a:pt x="5251315" y="4461753"/>
                      <a:pt x="5350213" y="4319081"/>
                    </a:cubicBezTo>
                    <a:cubicBezTo>
                      <a:pt x="5449111" y="4176409"/>
                      <a:pt x="5544766" y="4061298"/>
                      <a:pt x="5622587" y="3920247"/>
                    </a:cubicBezTo>
                    <a:cubicBezTo>
                      <a:pt x="5700408" y="3779196"/>
                      <a:pt x="5762018" y="3617069"/>
                      <a:pt x="5817141" y="3472775"/>
                    </a:cubicBezTo>
                    <a:cubicBezTo>
                      <a:pt x="5872264" y="3328481"/>
                      <a:pt x="5899826" y="3171217"/>
                      <a:pt x="5953328" y="3054485"/>
                    </a:cubicBezTo>
                    <a:cubicBezTo>
                      <a:pt x="6006830" y="2937753"/>
                      <a:pt x="6089515" y="2866417"/>
                      <a:pt x="6138153" y="2772383"/>
                    </a:cubicBezTo>
                    <a:cubicBezTo>
                      <a:pt x="6186791" y="2678349"/>
                      <a:pt x="6219218" y="2585936"/>
                      <a:pt x="6245158" y="2490281"/>
                    </a:cubicBezTo>
                    <a:cubicBezTo>
                      <a:pt x="6271098" y="2394626"/>
                      <a:pt x="6256507" y="2313562"/>
                      <a:pt x="6293796" y="2198451"/>
                    </a:cubicBezTo>
                    <a:cubicBezTo>
                      <a:pt x="6331085" y="2083340"/>
                      <a:pt x="6449439" y="1900136"/>
                      <a:pt x="6468894" y="1799617"/>
                    </a:cubicBezTo>
                    <a:cubicBezTo>
                      <a:pt x="6488349" y="1699098"/>
                      <a:pt x="6405664" y="1655324"/>
                      <a:pt x="6410528" y="1595337"/>
                    </a:cubicBezTo>
                    <a:cubicBezTo>
                      <a:pt x="6415392" y="1535350"/>
                      <a:pt x="6478622" y="1511030"/>
                      <a:pt x="6498077" y="1439694"/>
                    </a:cubicBezTo>
                    <a:cubicBezTo>
                      <a:pt x="6517532" y="1368358"/>
                      <a:pt x="6527260" y="1251626"/>
                      <a:pt x="6527260" y="1167320"/>
                    </a:cubicBezTo>
                    <a:cubicBezTo>
                      <a:pt x="6527260" y="1083014"/>
                      <a:pt x="6481864" y="1016541"/>
                      <a:pt x="6498077" y="933856"/>
                    </a:cubicBezTo>
                    <a:cubicBezTo>
                      <a:pt x="6514290" y="851171"/>
                      <a:pt x="6609945" y="760379"/>
                      <a:pt x="6624536" y="671209"/>
                    </a:cubicBezTo>
                    <a:cubicBezTo>
                      <a:pt x="6639127" y="582039"/>
                      <a:pt x="6592111" y="510702"/>
                      <a:pt x="6585626" y="398834"/>
                    </a:cubicBezTo>
                    <a:cubicBezTo>
                      <a:pt x="6579141" y="286966"/>
                      <a:pt x="6582383" y="143483"/>
                      <a:pt x="6585626" y="0"/>
                    </a:cubicBezTo>
                  </a:path>
                </a:pathLst>
              </a:custGeom>
              <a:noFill/>
              <a:ln w="635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pic>
            <p:nvPicPr>
              <p:cNvPr id="46" name="Image 45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312829" y="2154354"/>
                <a:ext cx="266394" cy="204449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bg1"/>
                </a:solidFill>
              </a:ln>
            </p:spPr>
          </p:pic>
          <p:cxnSp>
            <p:nvCxnSpPr>
              <p:cNvPr id="47" name="Connecteur droit 46"/>
              <p:cNvCxnSpPr/>
              <p:nvPr/>
            </p:nvCxnSpPr>
            <p:spPr>
              <a:xfrm>
                <a:off x="4579223" y="2154354"/>
                <a:ext cx="230120" cy="126082"/>
              </a:xfrm>
              <a:prstGeom prst="line">
                <a:avLst/>
              </a:prstGeom>
              <a:ln>
                <a:solidFill>
                  <a:schemeClr val="bg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 flipV="1">
                <a:off x="4583386" y="2280436"/>
                <a:ext cx="225958" cy="74616"/>
              </a:xfrm>
              <a:prstGeom prst="line">
                <a:avLst/>
              </a:prstGeom>
              <a:ln>
                <a:solidFill>
                  <a:schemeClr val="bg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ZoneTexte 48">
                <a:extLst>
                  <a:ext uri="{FF2B5EF4-FFF2-40B4-BE49-F238E27FC236}">
                    <a16:creationId xmlns:a16="http://schemas.microsoft.com/office/drawing/2014/main" xmlns="" id="{E936CB28-128B-6CE5-3AC9-C0A99D797AD8}"/>
                  </a:ext>
                </a:extLst>
              </p:cNvPr>
              <p:cNvSpPr txBox="1"/>
              <p:nvPr/>
            </p:nvSpPr>
            <p:spPr>
              <a:xfrm>
                <a:off x="4222504" y="2072381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/>
                    </a:solidFill>
                  </a:rPr>
                  <a:t>*</a:t>
                </a:r>
                <a:endParaRPr lang="en-US" sz="1600" b="1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50" name="Groupe 49"/>
            <p:cNvGrpSpPr/>
            <p:nvPr/>
          </p:nvGrpSpPr>
          <p:grpSpPr>
            <a:xfrm>
              <a:off x="6490608" y="2336088"/>
              <a:ext cx="1064847" cy="1064837"/>
              <a:chOff x="8171100" y="395815"/>
              <a:chExt cx="1176450" cy="1176439"/>
            </a:xfrm>
          </p:grpSpPr>
          <p:pic>
            <p:nvPicPr>
              <p:cNvPr id="51" name="Image 50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247970" y="470903"/>
                <a:ext cx="756705" cy="760450"/>
              </a:xfrm>
              <a:prstGeom prst="rect">
                <a:avLst/>
              </a:prstGeom>
            </p:spPr>
          </p:pic>
          <p:pic>
            <p:nvPicPr>
              <p:cNvPr id="52" name="Image 51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8247969" y="1240497"/>
                <a:ext cx="756705" cy="331757"/>
              </a:xfrm>
              <a:prstGeom prst="rect">
                <a:avLst/>
              </a:prstGeom>
            </p:spPr>
          </p:pic>
          <p:pic>
            <p:nvPicPr>
              <p:cNvPr id="53" name="Image 52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9023886" y="478646"/>
                <a:ext cx="323664" cy="752707"/>
              </a:xfrm>
              <a:prstGeom prst="rect">
                <a:avLst/>
              </a:prstGeom>
            </p:spPr>
          </p:pic>
          <p:sp>
            <p:nvSpPr>
              <p:cNvPr id="54" name="ZoneTexte 53">
                <a:extLst>
                  <a:ext uri="{FF2B5EF4-FFF2-40B4-BE49-F238E27FC236}">
                    <a16:creationId xmlns:a16="http://schemas.microsoft.com/office/drawing/2014/main" xmlns="" id="{E936CB28-128B-6CE5-3AC9-C0A99D797AD8}"/>
                  </a:ext>
                </a:extLst>
              </p:cNvPr>
              <p:cNvSpPr txBox="1"/>
              <p:nvPr/>
            </p:nvSpPr>
            <p:spPr>
              <a:xfrm>
                <a:off x="8171100" y="395815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</p:grp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xmlns="" id="{BB41488A-639D-260D-B0E0-D89A9759CE4B}"/>
                </a:ext>
              </a:extLst>
            </p:cNvPr>
            <p:cNvSpPr txBox="1"/>
            <p:nvPr/>
          </p:nvSpPr>
          <p:spPr>
            <a:xfrm>
              <a:off x="3338845" y="-37113"/>
              <a:ext cx="82532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 smtClean="0"/>
                <a:t>B</a:t>
              </a:r>
              <a:endParaRPr lang="en-US" sz="2400" dirty="0"/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852133" y="1996948"/>
            <a:ext cx="4922765" cy="3155828"/>
            <a:chOff x="3338845" y="3620846"/>
            <a:chExt cx="4922765" cy="3155828"/>
          </a:xfrm>
        </p:grpSpPr>
        <p:grpSp>
          <p:nvGrpSpPr>
            <p:cNvPr id="27" name="Groupe 26">
              <a:extLst>
                <a:ext uri="{FF2B5EF4-FFF2-40B4-BE49-F238E27FC236}">
                  <a16:creationId xmlns:a16="http://schemas.microsoft.com/office/drawing/2014/main" xmlns="" id="{21E2AD30-5A77-3555-9D56-588E1446A744}"/>
                </a:ext>
              </a:extLst>
            </p:cNvPr>
            <p:cNvGrpSpPr/>
            <p:nvPr/>
          </p:nvGrpSpPr>
          <p:grpSpPr>
            <a:xfrm>
              <a:off x="3735330" y="3702620"/>
              <a:ext cx="4526280" cy="2312137"/>
              <a:chOff x="4809682" y="57336"/>
              <a:chExt cx="4526280" cy="2312137"/>
            </a:xfrm>
          </p:grpSpPr>
          <p:pic>
            <p:nvPicPr>
              <p:cNvPr id="28" name="Image 27">
                <a:extLst>
                  <a:ext uri="{FF2B5EF4-FFF2-40B4-BE49-F238E27FC236}">
                    <a16:creationId xmlns:a16="http://schemas.microsoft.com/office/drawing/2014/main" xmlns="" id="{267A4457-1970-30CC-DA9A-1C4B63E64AE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rcRect t="1993"/>
              <a:stretch/>
            </p:blipFill>
            <p:spPr>
              <a:xfrm>
                <a:off x="4809682" y="57336"/>
                <a:ext cx="4526280" cy="2312137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29" name="ZoneTexte 28">
                <a:extLst>
                  <a:ext uri="{FF2B5EF4-FFF2-40B4-BE49-F238E27FC236}">
                    <a16:creationId xmlns:a16="http://schemas.microsoft.com/office/drawing/2014/main" xmlns="" id="{E936CB28-128B-6CE5-3AC9-C0A99D797AD8}"/>
                  </a:ext>
                </a:extLst>
              </p:cNvPr>
              <p:cNvSpPr txBox="1"/>
              <p:nvPr/>
            </p:nvSpPr>
            <p:spPr>
              <a:xfrm>
                <a:off x="5600463" y="1679058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/>
                    </a:solidFill>
                  </a:rPr>
                  <a:t>*</a:t>
                </a:r>
                <a:endParaRPr lang="en-US" sz="1600" b="1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30" name="Groupe 29">
              <a:extLst>
                <a:ext uri="{FF2B5EF4-FFF2-40B4-BE49-F238E27FC236}">
                  <a16:creationId xmlns:a16="http://schemas.microsoft.com/office/drawing/2014/main" xmlns="" id="{072FF06C-EAB5-449D-C089-45C8814C1801}"/>
                </a:ext>
              </a:extLst>
            </p:cNvPr>
            <p:cNvGrpSpPr/>
            <p:nvPr/>
          </p:nvGrpSpPr>
          <p:grpSpPr>
            <a:xfrm>
              <a:off x="4213224" y="5980355"/>
              <a:ext cx="1219204" cy="796319"/>
              <a:chOff x="6822662" y="2687577"/>
              <a:chExt cx="1219204" cy="796319"/>
            </a:xfrm>
          </p:grpSpPr>
          <p:pic>
            <p:nvPicPr>
              <p:cNvPr id="31" name="Image 30">
                <a:extLst>
                  <a:ext uri="{FF2B5EF4-FFF2-40B4-BE49-F238E27FC236}">
                    <a16:creationId xmlns:a16="http://schemas.microsoft.com/office/drawing/2014/main" xmlns="" id="{6282FF44-C89D-26E5-5EDB-0BC5E851802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rcRect l="21976" t="30069" r="59388" b="31163"/>
              <a:stretch/>
            </p:blipFill>
            <p:spPr>
              <a:xfrm>
                <a:off x="6860071" y="2758296"/>
                <a:ext cx="904520" cy="430257"/>
              </a:xfrm>
              <a:prstGeom prst="rect">
                <a:avLst/>
              </a:prstGeom>
            </p:spPr>
          </p:pic>
          <p:pic>
            <p:nvPicPr>
              <p:cNvPr id="32" name="Image 31">
                <a:extLst>
                  <a:ext uri="{FF2B5EF4-FFF2-40B4-BE49-F238E27FC236}">
                    <a16:creationId xmlns:a16="http://schemas.microsoft.com/office/drawing/2014/main" xmlns="" id="{6DF514D9-86EE-8531-768B-9239067730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rcRect l="21976" t="82887" r="59388"/>
              <a:stretch/>
            </p:blipFill>
            <p:spPr>
              <a:xfrm>
                <a:off x="6860071" y="3199172"/>
                <a:ext cx="904520" cy="284724"/>
              </a:xfrm>
              <a:prstGeom prst="rect">
                <a:avLst/>
              </a:prstGeom>
            </p:spPr>
          </p:pic>
          <p:pic>
            <p:nvPicPr>
              <p:cNvPr id="33" name="Image 32">
                <a:extLst>
                  <a:ext uri="{FF2B5EF4-FFF2-40B4-BE49-F238E27FC236}">
                    <a16:creationId xmlns:a16="http://schemas.microsoft.com/office/drawing/2014/main" xmlns="" id="{3A40E984-8CE1-4BB2-E8DF-188221C2E7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rcRect l="79727" t="79951" r="2494" b="9708"/>
              <a:stretch/>
            </p:blipFill>
            <p:spPr>
              <a:xfrm>
                <a:off x="7775437" y="2758296"/>
                <a:ext cx="266429" cy="430257"/>
              </a:xfrm>
              <a:prstGeom prst="rect">
                <a:avLst/>
              </a:prstGeom>
            </p:spPr>
          </p:pic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xmlns="" id="{49002EE0-EE44-C368-BC32-596EA9F104CE}"/>
                  </a:ext>
                </a:extLst>
              </p:cNvPr>
              <p:cNvSpPr txBox="1"/>
              <p:nvPr/>
            </p:nvSpPr>
            <p:spPr>
              <a:xfrm>
                <a:off x="6822662" y="2687577"/>
                <a:ext cx="159366" cy="1905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</p:grp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xmlns="" id="{958B7895-4B83-CAA5-5C0C-3E6D9B156867}"/>
                </a:ext>
              </a:extLst>
            </p:cNvPr>
            <p:cNvSpPr txBox="1"/>
            <p:nvPr/>
          </p:nvSpPr>
          <p:spPr>
            <a:xfrm>
              <a:off x="3338845" y="3620846"/>
              <a:ext cx="82532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 smtClean="0"/>
                <a:t>A</a:t>
              </a:r>
              <a:endParaRPr lang="en-US" sz="2400" dirty="0"/>
            </a:p>
          </p:txBody>
        </p:sp>
      </p:grpSp>
      <p:sp>
        <p:nvSpPr>
          <p:cNvPr id="4" name="ZoneTexte 3"/>
          <p:cNvSpPr txBox="1"/>
          <p:nvPr/>
        </p:nvSpPr>
        <p:spPr>
          <a:xfrm>
            <a:off x="1201205" y="1721066"/>
            <a:ext cx="17550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err="1" smtClean="0"/>
              <a:t>Infected</a:t>
            </a:r>
            <a:r>
              <a:rPr lang="fr-FR" sz="1600" dirty="0" smtClean="0"/>
              <a:t> </a:t>
            </a:r>
            <a:r>
              <a:rPr lang="fr-FR" sz="1600" dirty="0" err="1" smtClean="0"/>
              <a:t>with</a:t>
            </a:r>
            <a:r>
              <a:rPr lang="fr-FR" sz="1600" dirty="0" smtClean="0"/>
              <a:t> RP73</a:t>
            </a:r>
            <a:endParaRPr lang="fr-FR" sz="1600" dirty="0"/>
          </a:p>
        </p:txBody>
      </p:sp>
      <p:sp>
        <p:nvSpPr>
          <p:cNvPr id="57" name="ZoneTexte 56"/>
          <p:cNvSpPr txBox="1"/>
          <p:nvPr/>
        </p:nvSpPr>
        <p:spPr>
          <a:xfrm>
            <a:off x="3455653" y="1721066"/>
            <a:ext cx="12725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Non-</a:t>
            </a:r>
            <a:r>
              <a:rPr lang="fr-FR" sz="1600" dirty="0" err="1" smtClean="0"/>
              <a:t>infected</a:t>
            </a:r>
            <a:endParaRPr lang="fr-FR" sz="1600" dirty="0"/>
          </a:p>
        </p:txBody>
      </p:sp>
      <p:sp>
        <p:nvSpPr>
          <p:cNvPr id="58" name="ZoneTexte 57"/>
          <p:cNvSpPr txBox="1"/>
          <p:nvPr/>
        </p:nvSpPr>
        <p:spPr>
          <a:xfrm>
            <a:off x="6492285" y="1721066"/>
            <a:ext cx="23948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err="1" smtClean="0"/>
              <a:t>Infected</a:t>
            </a:r>
            <a:r>
              <a:rPr lang="fr-FR" sz="1600" dirty="0" smtClean="0"/>
              <a:t> </a:t>
            </a:r>
            <a:r>
              <a:rPr lang="fr-FR" sz="1600" dirty="0" err="1" smtClean="0"/>
              <a:t>with</a:t>
            </a:r>
            <a:r>
              <a:rPr lang="fr-FR" sz="1600" dirty="0" smtClean="0"/>
              <a:t> PAO1 (</a:t>
            </a:r>
            <a:r>
              <a:rPr lang="fr-FR" sz="1600" dirty="0" err="1" smtClean="0"/>
              <a:t>fish</a:t>
            </a:r>
            <a:r>
              <a:rPr lang="fr-FR" sz="1600" dirty="0" smtClean="0"/>
              <a:t> 1)</a:t>
            </a:r>
            <a:endParaRPr lang="fr-FR" sz="1600" dirty="0"/>
          </a:p>
        </p:txBody>
      </p:sp>
      <p:sp>
        <p:nvSpPr>
          <p:cNvPr id="59" name="ZoneTexte 58"/>
          <p:cNvSpPr txBox="1"/>
          <p:nvPr/>
        </p:nvSpPr>
        <p:spPr>
          <a:xfrm>
            <a:off x="8851758" y="1721066"/>
            <a:ext cx="23948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err="1" smtClean="0"/>
              <a:t>Infected</a:t>
            </a:r>
            <a:r>
              <a:rPr lang="fr-FR" sz="1600" dirty="0" smtClean="0"/>
              <a:t> </a:t>
            </a:r>
            <a:r>
              <a:rPr lang="fr-FR" sz="1600" dirty="0" err="1" smtClean="0"/>
              <a:t>with</a:t>
            </a:r>
            <a:r>
              <a:rPr lang="fr-FR" sz="1600" dirty="0" smtClean="0"/>
              <a:t> PAO1 (</a:t>
            </a:r>
            <a:r>
              <a:rPr lang="fr-FR" sz="1600" dirty="0" err="1" smtClean="0"/>
              <a:t>fish</a:t>
            </a:r>
            <a:r>
              <a:rPr lang="fr-FR" sz="1600" dirty="0" smtClean="0"/>
              <a:t> 2)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420750802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9</TotalTime>
  <Words>32</Words>
  <Application>Microsoft Office PowerPoint</Application>
  <PresentationFormat>Grand écran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ephane.pont</dc:creator>
  <cp:lastModifiedBy>anne</cp:lastModifiedBy>
  <cp:revision>74</cp:revision>
  <cp:lastPrinted>2024-12-10T15:08:57Z</cp:lastPrinted>
  <dcterms:created xsi:type="dcterms:W3CDTF">2024-11-05T09:42:14Z</dcterms:created>
  <dcterms:modified xsi:type="dcterms:W3CDTF">2025-01-27T17:40:45Z</dcterms:modified>
</cp:coreProperties>
</file>